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D320E-A52A-4A08-ACFD-EBF18D7549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6C6C5-9573-4EA4-870A-C134967A9F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90C41-1217-4DBF-B71F-11DB1D6917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AAF10-A0DD-4DF7-8C3D-84D8967CDA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95214-D56F-4B68-A2AA-BEB178BB8C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68B59-4C66-47C4-A768-00BCBBDDC8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7276F-D32B-4E39-807A-55E8C74A0E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5153F-B857-4595-BB6C-69FF76F1A4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AE063-CE1B-4F8F-8C24-96EBCB5827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9CF4A-7847-4111-B5D3-1C08B0ACF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BF83F-C423-428D-84DC-B201460DB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D886C-8B77-41F2-9505-885F80F6ED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C71033-E86B-450B-AEC9-AA6F8BCE2189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324000" y="765000"/>
            <a:ext cx="5952960" cy="4069080"/>
          </a:xfrm>
          <a:prstGeom prst="rect">
            <a:avLst/>
          </a:prstGeom>
          <a:ln w="0">
            <a:noFill/>
          </a:ln>
        </p:spPr>
      </p:pic>
      <p:sp>
        <p:nvSpPr>
          <p:cNvPr id="42" name="Rettangolo 47"/>
          <p:cNvSpPr/>
          <p:nvPr/>
        </p:nvSpPr>
        <p:spPr>
          <a:xfrm>
            <a:off x="539640" y="115920"/>
            <a:ext cx="648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Potenza et al, S1 Fig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ttangolo 12"/>
          <p:cNvSpPr/>
          <p:nvPr/>
        </p:nvSpPr>
        <p:spPr>
          <a:xfrm>
            <a:off x="395280" y="4941720"/>
            <a:ext cx="8137440" cy="186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Parameters of left ventricular function and ischemic area in hearts exposed to I/R or vehicle-I/R at the onset of ischemia.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Hearts exposed to 30 min ischemia followed by 180 min reperfusion (I/R group) were compared with hearts infused with vehicle alone (3 mL/1 min; vehicle I/R) at the onset of ischemia; both functional parameters (A-D) and the extent of infarct area (E) did not significantly differ between hearts from these two groups. “Vehicle”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was modified Krebs’ Henseleit solution (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composed of (mmol/l): 118.5 NaCl; 4.7 KCl; 1.2 MgSO</a:t>
            </a:r>
            <a:r>
              <a:rPr b="0" lang="it-IT" sz="16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; 1.2 KH</a:t>
            </a:r>
            <a:r>
              <a:rPr b="0" lang="it-IT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PO</a:t>
            </a:r>
            <a:r>
              <a:rPr b="0" lang="it-IT" sz="16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; 1.25 CaCl</a:t>
            </a:r>
            <a:r>
              <a:rPr b="0" lang="it-IT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(H</a:t>
            </a:r>
            <a:r>
              <a:rPr b="0" lang="it-IT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O); 25 NaHCO</a:t>
            </a:r>
            <a:r>
              <a:rPr b="0" lang="it-IT" sz="1600" spc="-1" strike="noStrike" baseline="-25000">
                <a:solidFill>
                  <a:srgbClr val="000000"/>
                </a:solidFill>
                <a:latin typeface="Calibri"/>
              </a:rPr>
              <a:t>3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; 11 glucose)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containing DMSO 0.1%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5" descr=""/>
          <p:cNvPicPr/>
          <p:nvPr/>
        </p:nvPicPr>
        <p:blipFill>
          <a:blip r:embed="rId2"/>
          <a:srcRect l="44453" t="35513" r="28884" b="55148"/>
          <a:stretch/>
        </p:blipFill>
        <p:spPr>
          <a:xfrm>
            <a:off x="6588000" y="2637000"/>
            <a:ext cx="1105200" cy="9205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4" descr=""/>
          <p:cNvPicPr/>
          <p:nvPr/>
        </p:nvPicPr>
        <p:blipFill>
          <a:blip r:embed="rId3"/>
          <a:srcRect l="56931" t="63527" r="16110" b="26107"/>
          <a:stretch/>
        </p:blipFill>
        <p:spPr>
          <a:xfrm>
            <a:off x="7596360" y="2637000"/>
            <a:ext cx="1008000" cy="8953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" descr=""/>
          <p:cNvPicPr/>
          <p:nvPr/>
        </p:nvPicPr>
        <p:blipFill>
          <a:blip r:embed="rId4"/>
          <a:stretch/>
        </p:blipFill>
        <p:spPr>
          <a:xfrm>
            <a:off x="6084720" y="620640"/>
            <a:ext cx="2573640" cy="2049480"/>
          </a:xfrm>
          <a:prstGeom prst="rect">
            <a:avLst/>
          </a:prstGeom>
          <a:ln w="0">
            <a:noFill/>
          </a:ln>
        </p:spPr>
      </p:pic>
      <p:sp>
        <p:nvSpPr>
          <p:cNvPr id="47" name="CasellaDiTesto 9"/>
          <p:cNvSpPr/>
          <p:nvPr/>
        </p:nvSpPr>
        <p:spPr>
          <a:xfrm>
            <a:off x="326160" y="6922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CasellaDiTesto 10"/>
          <p:cNvSpPr/>
          <p:nvPr/>
        </p:nvSpPr>
        <p:spPr>
          <a:xfrm>
            <a:off x="331200" y="269244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asellaDiTesto 11"/>
          <p:cNvSpPr/>
          <p:nvPr/>
        </p:nvSpPr>
        <p:spPr>
          <a:xfrm>
            <a:off x="3321000" y="269244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12"/>
          <p:cNvSpPr/>
          <p:nvPr/>
        </p:nvSpPr>
        <p:spPr>
          <a:xfrm>
            <a:off x="3319560" y="6922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sellaDiTesto 13"/>
          <p:cNvSpPr/>
          <p:nvPr/>
        </p:nvSpPr>
        <p:spPr>
          <a:xfrm>
            <a:off x="6057000" y="69228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0-18T09:45:05Z</dcterms:created>
  <dc:creator>Pc</dc:creator>
  <dc:description/>
  <dc:language>en-US</dc:language>
  <cp:lastModifiedBy>Monica</cp:lastModifiedBy>
  <dcterms:modified xsi:type="dcterms:W3CDTF">2018-10-30T11:58:22Z</dcterms:modified>
  <cp:revision>8</cp:revision>
  <dc:subject/>
  <dc:title>Diapositiva 1</dc:title>
</cp:coreProperties>
</file>